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  <p:sldId id="257" r:id="rId6"/>
    <p:sldId id="25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4" autoAdjust="0"/>
    <p:restoredTop sz="96395" autoAdjust="0"/>
  </p:normalViewPr>
  <p:slideViewPr>
    <p:cSldViewPr snapToGrid="0">
      <p:cViewPr>
        <p:scale>
          <a:sx n="120" d="100"/>
          <a:sy n="120" d="100"/>
        </p:scale>
        <p:origin x="150" y="-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7233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6710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85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2800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2452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13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8127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3268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330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448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0014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238D4-0729-4CF6-9BB5-DF79293FC09A}" type="datetimeFigureOut">
              <a:rPr lang="en-GB" smtClean="0"/>
              <a:t>20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48F83-40D6-4EA9-8DF8-F3D7B2010F6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1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77329" y="911544"/>
            <a:ext cx="8899584" cy="787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u="sng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 </a:t>
            </a:r>
            <a:r>
              <a:rPr lang="en-GB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– Gating strategy for flow cytometry</a:t>
            </a:r>
          </a:p>
          <a:p>
            <a:pPr marL="342900" lvl="0" indent="-342900">
              <a:lnSpc>
                <a:spcPct val="107000"/>
              </a:lnSpc>
              <a:spcAft>
                <a:spcPts val="800"/>
              </a:spcAft>
              <a:buFont typeface="+mj-lt"/>
              <a:buAutoNum type="arabicPeriod"/>
            </a:pPr>
            <a:r>
              <a:rPr lang="en-GB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 of monocytes (CD14+) in the lymphocyte (CD45+) </a:t>
            </a:r>
            <a:r>
              <a:rPr lang="en-GB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pulation.</a:t>
            </a:r>
            <a:endParaRPr lang="en-GB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809" y="2289999"/>
            <a:ext cx="3437469" cy="337667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6148" y="2287528"/>
            <a:ext cx="3292954" cy="323471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3936" y="2306634"/>
            <a:ext cx="3281634" cy="325499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794293" y="5331123"/>
            <a:ext cx="59824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Palatino Linotype" panose="02040502050505030304" pitchFamily="18" charset="0"/>
              </a:rPr>
              <a:t>FSC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-38944" y="3585711"/>
            <a:ext cx="59182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Palatino Linotype" panose="02040502050505030304" pitchFamily="18" charset="0"/>
              </a:rPr>
              <a:t>S</a:t>
            </a:r>
            <a:r>
              <a:rPr lang="en-GB" dirty="0" smtClean="0">
                <a:latin typeface="Palatino Linotype" panose="02040502050505030304" pitchFamily="18" charset="0"/>
              </a:rPr>
              <a:t>SC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423137" y="5319621"/>
            <a:ext cx="140294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Palatino Linotype" panose="02040502050505030304" pitchFamily="18" charset="0"/>
              </a:rPr>
              <a:t>CD45 -FITC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4003970" y="3617341"/>
            <a:ext cx="59182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>
                <a:latin typeface="Palatino Linotype" panose="02040502050505030304" pitchFamily="18" charset="0"/>
              </a:rPr>
              <a:t>S</a:t>
            </a:r>
            <a:r>
              <a:rPr lang="en-GB" dirty="0" smtClean="0">
                <a:latin typeface="Palatino Linotype" panose="02040502050505030304" pitchFamily="18" charset="0"/>
              </a:rPr>
              <a:t>SC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265650" y="2935855"/>
            <a:ext cx="125528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Palatino Linotype" panose="02040502050505030304" pitchFamily="18" charset="0"/>
              </a:rPr>
              <a:t>Lymphocytes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7175177" y="3640344"/>
            <a:ext cx="212821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Palatino Linotype" panose="02040502050505030304" pitchFamily="18" charset="0"/>
              </a:rPr>
              <a:t>CD14-PerCP-Cy5.5</a:t>
            </a:r>
            <a:endParaRPr lang="en-GB" dirty="0">
              <a:latin typeface="Palatino Linotype" panose="0204050205050503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0117043" y="1949258"/>
            <a:ext cx="1255472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GB" sz="1400" dirty="0" smtClean="0">
                <a:latin typeface="Palatino Linotype" panose="02040502050505030304" pitchFamily="18" charset="0"/>
              </a:rPr>
              <a:t>CD45+CD14+</a:t>
            </a:r>
          </a:p>
          <a:p>
            <a:pPr algn="ctr"/>
            <a:r>
              <a:rPr lang="en-GB" sz="1400" dirty="0" smtClean="0">
                <a:latin typeface="Palatino Linotype" panose="02040502050505030304" pitchFamily="18" charset="0"/>
              </a:rPr>
              <a:t>Monocytes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  <p:sp>
        <p:nvSpPr>
          <p:cNvPr id="16" name="Right Arrow 15"/>
          <p:cNvSpPr/>
          <p:nvPr/>
        </p:nvSpPr>
        <p:spPr>
          <a:xfrm>
            <a:off x="3683479" y="3683480"/>
            <a:ext cx="379562" cy="224287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ight Arrow 16"/>
          <p:cNvSpPr/>
          <p:nvPr/>
        </p:nvSpPr>
        <p:spPr>
          <a:xfrm>
            <a:off x="7562491" y="3715110"/>
            <a:ext cx="379562" cy="224287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Box 17"/>
          <p:cNvSpPr txBox="1"/>
          <p:nvPr/>
        </p:nvSpPr>
        <p:spPr>
          <a:xfrm>
            <a:off x="9381834" y="5366519"/>
            <a:ext cx="140294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Palatino Linotype" panose="02040502050505030304" pitchFamily="18" charset="0"/>
              </a:rPr>
              <a:t>CD45 -FITC</a:t>
            </a:r>
            <a:endParaRPr lang="en-GB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6062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25951" y="0"/>
            <a:ext cx="9287774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u="none" strike="noStrike" dirty="0" smtClean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lang="en-GB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GB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dirty="0" smtClean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rcentage of M2 macrophages (CD45+HLA-DR+CD14+CD163+) in the live population</a:t>
            </a:r>
            <a:endParaRPr lang="en-GB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11086" y="4166557"/>
            <a:ext cx="1548822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Palatino Linotype" panose="02040502050505030304" pitchFamily="18" charset="0"/>
              </a:rPr>
              <a:t>M2 macrophages</a:t>
            </a:r>
          </a:p>
          <a:p>
            <a:r>
              <a:rPr lang="en-GB" sz="1400" dirty="0" smtClean="0">
                <a:latin typeface="Palatino Linotype" panose="02040502050505030304" pitchFamily="18" charset="0"/>
              </a:rPr>
              <a:t>(CD163+)</a:t>
            </a:r>
            <a:endParaRPr lang="en-GB" sz="1400" dirty="0">
              <a:latin typeface="Palatino Linotype" panose="02040502050505030304" pitchFamily="18" charset="0"/>
            </a:endParaRPr>
          </a:p>
        </p:txBody>
      </p:sp>
      <p:sp>
        <p:nvSpPr>
          <p:cNvPr id="10" name="Right Arrow 9"/>
          <p:cNvSpPr/>
          <p:nvPr/>
        </p:nvSpPr>
        <p:spPr>
          <a:xfrm>
            <a:off x="4693375" y="1518249"/>
            <a:ext cx="448574" cy="284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ight Arrow 10"/>
          <p:cNvSpPr/>
          <p:nvPr/>
        </p:nvSpPr>
        <p:spPr>
          <a:xfrm rot="5400000">
            <a:off x="7544451" y="3471083"/>
            <a:ext cx="437769" cy="35122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9" name="Group 18"/>
          <p:cNvGrpSpPr/>
          <p:nvPr/>
        </p:nvGrpSpPr>
        <p:grpSpPr>
          <a:xfrm>
            <a:off x="6055550" y="3873262"/>
            <a:ext cx="2946470" cy="2984738"/>
            <a:chOff x="5975340" y="3873262"/>
            <a:chExt cx="2946470" cy="298473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5281" y="3873262"/>
              <a:ext cx="2826529" cy="2803586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6610206" y="6488668"/>
              <a:ext cx="212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14-PerCP-Cy5.5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5351153" y="4954646"/>
              <a:ext cx="161770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163-AF647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6016501" y="401181"/>
            <a:ext cx="2881116" cy="2925345"/>
            <a:chOff x="5952333" y="1026823"/>
            <a:chExt cx="2881116" cy="292534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29788" y="1026823"/>
              <a:ext cx="2703661" cy="2681716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 rot="16200000">
              <a:off x="5287890" y="2018789"/>
              <a:ext cx="169821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HLA-DR-PE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955763" y="3582836"/>
              <a:ext cx="14029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45 -FIT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093378" y="429445"/>
            <a:ext cx="2920715" cy="2928756"/>
            <a:chOff x="1487037" y="2122097"/>
            <a:chExt cx="2920715" cy="292875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32729" y="2122097"/>
              <a:ext cx="2775023" cy="2725947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 rot="16200000">
              <a:off x="1375788" y="3223402"/>
              <a:ext cx="59182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Palatino Linotype" panose="02040502050505030304" pitchFamily="18" charset="0"/>
                </a:rPr>
                <a:t>S</a:t>
              </a:r>
              <a:r>
                <a:rPr lang="en-GB" dirty="0" smtClean="0">
                  <a:latin typeface="Palatino Linotype" panose="02040502050505030304" pitchFamily="18" charset="0"/>
                </a:rPr>
                <a:t>S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21865" y="4681521"/>
              <a:ext cx="59824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FS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60605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0"/>
            <a:ext cx="9233553" cy="3761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457200">
              <a:lnSpc>
                <a:spcPct val="107000"/>
              </a:lnSpc>
              <a:spcAft>
                <a:spcPts val="800"/>
              </a:spcAft>
            </a:pPr>
            <a:r>
              <a:rPr lang="en-GB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GB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ercentage </a:t>
            </a:r>
            <a:r>
              <a:rPr lang="en-GB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umour </a:t>
            </a:r>
            <a:r>
              <a:rPr lang="en-GB" dirty="0" smtClean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(%CD45-HLA-DR-CD14-CD44+) </a:t>
            </a:r>
            <a:r>
              <a:rPr lang="en-GB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e live population</a:t>
            </a:r>
          </a:p>
        </p:txBody>
      </p:sp>
      <p:sp>
        <p:nvSpPr>
          <p:cNvPr id="8" name="Right Arrow 7"/>
          <p:cNvSpPr/>
          <p:nvPr/>
        </p:nvSpPr>
        <p:spPr>
          <a:xfrm>
            <a:off x="4701695" y="1692654"/>
            <a:ext cx="448574" cy="284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Right Arrow 8"/>
          <p:cNvSpPr/>
          <p:nvPr/>
        </p:nvSpPr>
        <p:spPr>
          <a:xfrm rot="5400000">
            <a:off x="7323887" y="3509000"/>
            <a:ext cx="439340" cy="377201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8" name="Group 17"/>
          <p:cNvGrpSpPr/>
          <p:nvPr/>
        </p:nvGrpSpPr>
        <p:grpSpPr>
          <a:xfrm>
            <a:off x="5811986" y="3890778"/>
            <a:ext cx="2945369" cy="2967222"/>
            <a:chOff x="5764278" y="3841438"/>
            <a:chExt cx="2945369" cy="2967222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02056" y="3841438"/>
              <a:ext cx="2807591" cy="2784802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6394537" y="6439328"/>
              <a:ext cx="212821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14-PerCP-Cy5.5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5280990" y="4929846"/>
              <a:ext cx="1335907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44-AP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6615561" y="4010025"/>
            <a:ext cx="1109214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 smtClean="0">
                <a:latin typeface="Palatino Linotype" panose="02040502050505030304" pitchFamily="18" charset="0"/>
              </a:rPr>
              <a:t>Tumour (CD44+)</a:t>
            </a:r>
            <a:endParaRPr lang="en-GB" sz="1200" dirty="0">
              <a:latin typeface="Palatino Linotype" panose="02040502050505030304" pitchFamily="18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5758001" y="409416"/>
            <a:ext cx="2994990" cy="3011889"/>
            <a:chOff x="5718244" y="862641"/>
            <a:chExt cx="2994990" cy="3011889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88247" y="862641"/>
              <a:ext cx="2824987" cy="2802057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5057396" y="1927778"/>
              <a:ext cx="169102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HLA-DR-PE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743864" y="3505198"/>
              <a:ext cx="140294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CD45 -FIT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1054176" y="426229"/>
            <a:ext cx="2977335" cy="3013111"/>
            <a:chOff x="1181397" y="1054382"/>
            <a:chExt cx="2977335" cy="301311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2977" y="1054382"/>
              <a:ext cx="2835755" cy="278560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 rot="16200000">
              <a:off x="1070148" y="2186283"/>
              <a:ext cx="591829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>
                  <a:latin typeface="Palatino Linotype" panose="02040502050505030304" pitchFamily="18" charset="0"/>
                </a:rPr>
                <a:t>S</a:t>
              </a:r>
              <a:r>
                <a:rPr lang="en-GB" dirty="0" smtClean="0">
                  <a:latin typeface="Palatino Linotype" panose="02040502050505030304" pitchFamily="18" charset="0"/>
                </a:rPr>
                <a:t>S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616895" y="3698161"/>
              <a:ext cx="59824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GB" dirty="0" smtClean="0">
                  <a:latin typeface="Palatino Linotype" panose="02040502050505030304" pitchFamily="18" charset="0"/>
                </a:rPr>
                <a:t>FSC</a:t>
              </a:r>
              <a:endParaRPr lang="en-GB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7072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824BCE1E7D72247960ED0B911B6A948" ma:contentTypeVersion="10" ma:contentTypeDescription="Create a new document." ma:contentTypeScope="" ma:versionID="2c79170f87379c31ab204dc2c7b73860">
  <xsd:schema xmlns:xsd="http://www.w3.org/2001/XMLSchema" xmlns:xs="http://www.w3.org/2001/XMLSchema" xmlns:p="http://schemas.microsoft.com/office/2006/metadata/properties" xmlns:ns2="15b6d8a7-dba3-4546-8e60-fbf4f9521170" xmlns:ns3="04dc99b2-5874-4aa7-8e92-3c8a80a26595" targetNamespace="http://schemas.microsoft.com/office/2006/metadata/properties" ma:root="true" ma:fieldsID="e7ad3c022a34440a084e625961864b47" ns2:_="" ns3:_="">
    <xsd:import namespace="15b6d8a7-dba3-4546-8e60-fbf4f9521170"/>
    <xsd:import namespace="04dc99b2-5874-4aa7-8e92-3c8a80a2659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ServiceLocation" minOccurs="0"/>
                <xsd:element ref="ns2:MediaServiceGenerationTime" minOccurs="0"/>
                <xsd:element ref="ns2:MediaServiceEventHashCode" minOccurs="0"/>
                <xsd:element ref="ns2:MediaServiceAutoTags" minOccurs="0"/>
                <xsd:element ref="ns2:MediaServiceOCR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5b6d8a7-dba3-4546-8e60-fbf4f952117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1" nillable="true" ma:displayName="Location" ma:internalName="MediaServiceLocation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4dc99b2-5874-4aa7-8e92-3c8a80a26595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9F361A2-8F34-4A50-B774-4A03F92F7FA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3D093562-DD6A-41D7-9029-4EA886D31E2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5b6d8a7-dba3-4546-8e60-fbf4f9521170"/>
    <ds:schemaRef ds:uri="04dc99b2-5874-4aa7-8e92-3c8a80a2659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6D1305C4-9890-47FB-BFA5-20D2B6CFBDE1}">
  <ds:schemaRefs>
    <ds:schemaRef ds:uri="http://purl.org/dc/terms/"/>
    <ds:schemaRef ds:uri="15b6d8a7-dba3-4546-8e60-fbf4f9521170"/>
    <ds:schemaRef ds:uri="http://purl.org/dc/dcmitype/"/>
    <ds:schemaRef ds:uri="http://purl.org/dc/elements/1.1/"/>
    <ds:schemaRef ds:uri="http://schemas.microsoft.com/office/2006/metadata/properties"/>
    <ds:schemaRef ds:uri="http://schemas.microsoft.com/office/2006/documentManagement/types"/>
    <ds:schemaRef ds:uri="04dc99b2-5874-4aa7-8e92-3c8a80a26595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75</Words>
  <Application>Microsoft Office PowerPoint</Application>
  <PresentationFormat>Widescreen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Plymou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aire Adams</dc:creator>
  <cp:lastModifiedBy>Claire Adams</cp:lastModifiedBy>
  <cp:revision>12</cp:revision>
  <dcterms:created xsi:type="dcterms:W3CDTF">2019-12-18T12:07:22Z</dcterms:created>
  <dcterms:modified xsi:type="dcterms:W3CDTF">2019-12-20T16:1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824BCE1E7D72247960ED0B911B6A948</vt:lpwstr>
  </property>
</Properties>
</file>